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3" r:id="rId2"/>
  </p:sldIdLst>
  <p:sldSz cx="6858000" cy="9906000" type="A4"/>
  <p:notesSz cx="6797675" cy="9926638"/>
  <p:defaultTextStyle>
    <a:defPPr>
      <a:defRPr lang="en-US"/>
    </a:defPPr>
    <a:lvl1pPr marL="0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1pPr>
    <a:lvl2pPr marL="359222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2pPr>
    <a:lvl3pPr marL="718444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3pPr>
    <a:lvl4pPr marL="1077666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4pPr>
    <a:lvl5pPr marL="1436888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5pPr>
    <a:lvl6pPr marL="1796110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6pPr>
    <a:lvl7pPr marL="2155332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7pPr>
    <a:lvl8pPr marL="2514554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8pPr>
    <a:lvl9pPr marL="2873776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353" autoAdjust="0"/>
    <p:restoredTop sz="99777" autoAdjust="0"/>
  </p:normalViewPr>
  <p:slideViewPr>
    <p:cSldViewPr snapToGrid="0">
      <p:cViewPr varScale="1">
        <p:scale>
          <a:sx n="75" d="100"/>
          <a:sy n="75" d="100"/>
        </p:scale>
        <p:origin x="3042" y="54"/>
      </p:cViewPr>
      <p:guideLst>
        <p:guide orient="horz" pos="312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1740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3480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5220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4696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5870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70441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82181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93921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0/24/202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626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0/24/202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83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3"/>
            <a:ext cx="1543050" cy="845220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0/24/202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399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0/24/202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225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10271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7"/>
          </a:xfrm>
        </p:spPr>
        <p:txBody>
          <a:bodyPr anchor="b"/>
          <a:lstStyle>
            <a:lvl1pPr marL="0" indent="0">
              <a:buNone/>
              <a:defRPr sz="5136">
                <a:solidFill>
                  <a:schemeClr val="tx1">
                    <a:tint val="75000"/>
                  </a:schemeClr>
                </a:solidFill>
              </a:defRPr>
            </a:lvl1pPr>
            <a:lvl2pPr marL="1174023" indent="0">
              <a:buNone/>
              <a:defRPr sz="4622">
                <a:solidFill>
                  <a:schemeClr val="tx1">
                    <a:tint val="75000"/>
                  </a:schemeClr>
                </a:solidFill>
              </a:defRPr>
            </a:lvl2pPr>
            <a:lvl3pPr marL="2348046" indent="0">
              <a:buNone/>
              <a:defRPr sz="4108">
                <a:solidFill>
                  <a:schemeClr val="tx1">
                    <a:tint val="75000"/>
                  </a:schemeClr>
                </a:solidFill>
              </a:defRPr>
            </a:lvl3pPr>
            <a:lvl4pPr marL="3522068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4pPr>
            <a:lvl5pPr marL="4696093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5pPr>
            <a:lvl6pPr marL="5870115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6pPr>
            <a:lvl7pPr marL="7044138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7pPr>
            <a:lvl8pPr marL="8218161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8pPr>
            <a:lvl9pPr marL="9392184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0/24/202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090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4"/>
            <a:ext cx="3028950" cy="6537502"/>
          </a:xfrm>
        </p:spPr>
        <p:txBody>
          <a:bodyPr/>
          <a:lstStyle>
            <a:lvl1pPr>
              <a:defRPr sz="7190"/>
            </a:lvl1pPr>
            <a:lvl2pPr>
              <a:defRPr sz="6163"/>
            </a:lvl2pPr>
            <a:lvl3pPr>
              <a:defRPr sz="5136"/>
            </a:lvl3pPr>
            <a:lvl4pPr>
              <a:defRPr sz="4622"/>
            </a:lvl4pPr>
            <a:lvl5pPr>
              <a:defRPr sz="4622"/>
            </a:lvl5pPr>
            <a:lvl6pPr>
              <a:defRPr sz="4622"/>
            </a:lvl6pPr>
            <a:lvl7pPr>
              <a:defRPr sz="4622"/>
            </a:lvl7pPr>
            <a:lvl8pPr>
              <a:defRPr sz="4622"/>
            </a:lvl8pPr>
            <a:lvl9pPr>
              <a:defRPr sz="4622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4"/>
            <a:ext cx="3028950" cy="6537502"/>
          </a:xfrm>
        </p:spPr>
        <p:txBody>
          <a:bodyPr/>
          <a:lstStyle>
            <a:lvl1pPr>
              <a:defRPr sz="7190"/>
            </a:lvl1pPr>
            <a:lvl2pPr>
              <a:defRPr sz="6163"/>
            </a:lvl2pPr>
            <a:lvl3pPr>
              <a:defRPr sz="5136"/>
            </a:lvl3pPr>
            <a:lvl4pPr>
              <a:defRPr sz="4622"/>
            </a:lvl4pPr>
            <a:lvl5pPr>
              <a:defRPr sz="4622"/>
            </a:lvl5pPr>
            <a:lvl6pPr>
              <a:defRPr sz="4622"/>
            </a:lvl6pPr>
            <a:lvl7pPr>
              <a:defRPr sz="4622"/>
            </a:lvl7pPr>
            <a:lvl8pPr>
              <a:defRPr sz="4622"/>
            </a:lvl8pPr>
            <a:lvl9pPr>
              <a:defRPr sz="4622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0/24/202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928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6163" b="1"/>
            </a:lvl1pPr>
            <a:lvl2pPr marL="1174023" indent="0">
              <a:buNone/>
              <a:defRPr sz="5136" b="1"/>
            </a:lvl2pPr>
            <a:lvl3pPr marL="2348046" indent="0">
              <a:buNone/>
              <a:defRPr sz="4622" b="1"/>
            </a:lvl3pPr>
            <a:lvl4pPr marL="3522068" indent="0">
              <a:buNone/>
              <a:defRPr sz="4108" b="1"/>
            </a:lvl4pPr>
            <a:lvl5pPr marL="4696093" indent="0">
              <a:buNone/>
              <a:defRPr sz="4108" b="1"/>
            </a:lvl5pPr>
            <a:lvl6pPr marL="5870115" indent="0">
              <a:buNone/>
              <a:defRPr sz="4108" b="1"/>
            </a:lvl6pPr>
            <a:lvl7pPr marL="7044138" indent="0">
              <a:buNone/>
              <a:defRPr sz="4108" b="1"/>
            </a:lvl7pPr>
            <a:lvl8pPr marL="8218161" indent="0">
              <a:buNone/>
              <a:defRPr sz="4108" b="1"/>
            </a:lvl8pPr>
            <a:lvl9pPr marL="9392184" indent="0">
              <a:buNone/>
              <a:defRPr sz="4108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6163"/>
            </a:lvl1pPr>
            <a:lvl2pPr>
              <a:defRPr sz="5136"/>
            </a:lvl2pPr>
            <a:lvl3pPr>
              <a:defRPr sz="4622"/>
            </a:lvl3pPr>
            <a:lvl4pPr>
              <a:defRPr sz="4108"/>
            </a:lvl4pPr>
            <a:lvl5pPr>
              <a:defRPr sz="4108"/>
            </a:lvl5pPr>
            <a:lvl6pPr>
              <a:defRPr sz="4108"/>
            </a:lvl6pPr>
            <a:lvl7pPr>
              <a:defRPr sz="4108"/>
            </a:lvl7pPr>
            <a:lvl8pPr>
              <a:defRPr sz="4108"/>
            </a:lvl8pPr>
            <a:lvl9pPr>
              <a:defRPr sz="4108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6163" b="1"/>
            </a:lvl1pPr>
            <a:lvl2pPr marL="1174023" indent="0">
              <a:buNone/>
              <a:defRPr sz="5136" b="1"/>
            </a:lvl2pPr>
            <a:lvl3pPr marL="2348046" indent="0">
              <a:buNone/>
              <a:defRPr sz="4622" b="1"/>
            </a:lvl3pPr>
            <a:lvl4pPr marL="3522068" indent="0">
              <a:buNone/>
              <a:defRPr sz="4108" b="1"/>
            </a:lvl4pPr>
            <a:lvl5pPr marL="4696093" indent="0">
              <a:buNone/>
              <a:defRPr sz="4108" b="1"/>
            </a:lvl5pPr>
            <a:lvl6pPr marL="5870115" indent="0">
              <a:buNone/>
              <a:defRPr sz="4108" b="1"/>
            </a:lvl6pPr>
            <a:lvl7pPr marL="7044138" indent="0">
              <a:buNone/>
              <a:defRPr sz="4108" b="1"/>
            </a:lvl7pPr>
            <a:lvl8pPr marL="8218161" indent="0">
              <a:buNone/>
              <a:defRPr sz="4108" b="1"/>
            </a:lvl8pPr>
            <a:lvl9pPr marL="9392184" indent="0">
              <a:buNone/>
              <a:defRPr sz="4108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6163"/>
            </a:lvl1pPr>
            <a:lvl2pPr>
              <a:defRPr sz="5136"/>
            </a:lvl2pPr>
            <a:lvl3pPr>
              <a:defRPr sz="4622"/>
            </a:lvl3pPr>
            <a:lvl4pPr>
              <a:defRPr sz="4108"/>
            </a:lvl4pPr>
            <a:lvl5pPr>
              <a:defRPr sz="4108"/>
            </a:lvl5pPr>
            <a:lvl6pPr>
              <a:defRPr sz="4108"/>
            </a:lvl6pPr>
            <a:lvl7pPr>
              <a:defRPr sz="4108"/>
            </a:lvl7pPr>
            <a:lvl8pPr>
              <a:defRPr sz="4108"/>
            </a:lvl8pPr>
            <a:lvl9pPr>
              <a:defRPr sz="4108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0/24/2025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105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0/24/2025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73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0/24/2025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123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5136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3" cy="8454497"/>
          </a:xfrm>
        </p:spPr>
        <p:txBody>
          <a:bodyPr/>
          <a:lstStyle>
            <a:lvl1pPr>
              <a:defRPr sz="8217"/>
            </a:lvl1pPr>
            <a:lvl2pPr>
              <a:defRPr sz="7190"/>
            </a:lvl2pPr>
            <a:lvl3pPr>
              <a:defRPr sz="6163"/>
            </a:lvl3pPr>
            <a:lvl4pPr>
              <a:defRPr sz="5136"/>
            </a:lvl4pPr>
            <a:lvl5pPr>
              <a:defRPr sz="5136"/>
            </a:lvl5pPr>
            <a:lvl6pPr>
              <a:defRPr sz="5136"/>
            </a:lvl6pPr>
            <a:lvl7pPr>
              <a:defRPr sz="5136"/>
            </a:lvl7pPr>
            <a:lvl8pPr>
              <a:defRPr sz="5136"/>
            </a:lvl8pPr>
            <a:lvl9pPr>
              <a:defRPr sz="5136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6"/>
            <a:ext cx="2256235" cy="6775980"/>
          </a:xfrm>
        </p:spPr>
        <p:txBody>
          <a:bodyPr/>
          <a:lstStyle>
            <a:lvl1pPr marL="0" indent="0">
              <a:buNone/>
              <a:defRPr sz="3595"/>
            </a:lvl1pPr>
            <a:lvl2pPr marL="1174023" indent="0">
              <a:buNone/>
              <a:defRPr sz="3081"/>
            </a:lvl2pPr>
            <a:lvl3pPr marL="2348046" indent="0">
              <a:buNone/>
              <a:defRPr sz="2568"/>
            </a:lvl3pPr>
            <a:lvl4pPr marL="3522068" indent="0">
              <a:buNone/>
              <a:defRPr sz="2311"/>
            </a:lvl4pPr>
            <a:lvl5pPr marL="4696093" indent="0">
              <a:buNone/>
              <a:defRPr sz="2311"/>
            </a:lvl5pPr>
            <a:lvl6pPr marL="5870115" indent="0">
              <a:buNone/>
              <a:defRPr sz="2311"/>
            </a:lvl6pPr>
            <a:lvl7pPr marL="7044138" indent="0">
              <a:buNone/>
              <a:defRPr sz="2311"/>
            </a:lvl7pPr>
            <a:lvl8pPr marL="8218161" indent="0">
              <a:buNone/>
              <a:defRPr sz="2311"/>
            </a:lvl8pPr>
            <a:lvl9pPr marL="9392184" indent="0">
              <a:buNone/>
              <a:defRPr sz="231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0/24/202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0068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5136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8217"/>
            </a:lvl1pPr>
            <a:lvl2pPr marL="1174023" indent="0">
              <a:buNone/>
              <a:defRPr sz="7190"/>
            </a:lvl2pPr>
            <a:lvl3pPr marL="2348046" indent="0">
              <a:buNone/>
              <a:defRPr sz="6163"/>
            </a:lvl3pPr>
            <a:lvl4pPr marL="3522068" indent="0">
              <a:buNone/>
              <a:defRPr sz="5136"/>
            </a:lvl4pPr>
            <a:lvl5pPr marL="4696093" indent="0">
              <a:buNone/>
              <a:defRPr sz="5136"/>
            </a:lvl5pPr>
            <a:lvl6pPr marL="5870115" indent="0">
              <a:buNone/>
              <a:defRPr sz="5136"/>
            </a:lvl6pPr>
            <a:lvl7pPr marL="7044138" indent="0">
              <a:buNone/>
              <a:defRPr sz="5136"/>
            </a:lvl7pPr>
            <a:lvl8pPr marL="8218161" indent="0">
              <a:buNone/>
              <a:defRPr sz="5136"/>
            </a:lvl8pPr>
            <a:lvl9pPr marL="9392184" indent="0">
              <a:buNone/>
              <a:defRPr sz="5136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3595"/>
            </a:lvl1pPr>
            <a:lvl2pPr marL="1174023" indent="0">
              <a:buNone/>
              <a:defRPr sz="3081"/>
            </a:lvl2pPr>
            <a:lvl3pPr marL="2348046" indent="0">
              <a:buNone/>
              <a:defRPr sz="2568"/>
            </a:lvl3pPr>
            <a:lvl4pPr marL="3522068" indent="0">
              <a:buNone/>
              <a:defRPr sz="2311"/>
            </a:lvl4pPr>
            <a:lvl5pPr marL="4696093" indent="0">
              <a:buNone/>
              <a:defRPr sz="2311"/>
            </a:lvl5pPr>
            <a:lvl6pPr marL="5870115" indent="0">
              <a:buNone/>
              <a:defRPr sz="2311"/>
            </a:lvl6pPr>
            <a:lvl7pPr marL="7044138" indent="0">
              <a:buNone/>
              <a:defRPr sz="2311"/>
            </a:lvl7pPr>
            <a:lvl8pPr marL="8218161" indent="0">
              <a:buNone/>
              <a:defRPr sz="2311"/>
            </a:lvl8pPr>
            <a:lvl9pPr marL="9392184" indent="0">
              <a:buNone/>
              <a:defRPr sz="231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0/24/202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897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4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0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7FB624-DC01-41C0-B6CF-4B8589DDAF31}" type="datetimeFigureOut">
              <a:rPr lang="en-US" smtClean="0"/>
              <a:pPr/>
              <a:t>10/24/202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0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0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769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348046" rtl="0" eaLnBrk="1" latinLnBrk="0" hangingPunct="1">
        <a:spcBef>
          <a:spcPct val="0"/>
        </a:spcBef>
        <a:buNone/>
        <a:defRPr sz="1129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80518" indent="-880518" algn="l" defTabSz="2348046" rtl="0" eaLnBrk="1" latinLnBrk="0" hangingPunct="1">
        <a:spcBef>
          <a:spcPct val="20000"/>
        </a:spcBef>
        <a:buFont typeface="Arial" pitchFamily="34" charset="0"/>
        <a:buChar char="•"/>
        <a:defRPr sz="8217" kern="1200">
          <a:solidFill>
            <a:schemeClr val="tx1"/>
          </a:solidFill>
          <a:latin typeface="+mn-lt"/>
          <a:ea typeface="+mn-ea"/>
          <a:cs typeface="+mn-cs"/>
        </a:defRPr>
      </a:lvl1pPr>
      <a:lvl2pPr marL="1907788" indent="-733764" algn="l" defTabSz="2348046" rtl="0" eaLnBrk="1" latinLnBrk="0" hangingPunct="1">
        <a:spcBef>
          <a:spcPct val="20000"/>
        </a:spcBef>
        <a:buFont typeface="Arial" pitchFamily="34" charset="0"/>
        <a:buChar char="–"/>
        <a:defRPr sz="7190" kern="1200">
          <a:solidFill>
            <a:schemeClr val="tx1"/>
          </a:solidFill>
          <a:latin typeface="+mn-lt"/>
          <a:ea typeface="+mn-ea"/>
          <a:cs typeface="+mn-cs"/>
        </a:defRPr>
      </a:lvl2pPr>
      <a:lvl3pPr marL="2935057" indent="-587011" algn="l" defTabSz="2348046" rtl="0" eaLnBrk="1" latinLnBrk="0" hangingPunct="1">
        <a:spcBef>
          <a:spcPct val="20000"/>
        </a:spcBef>
        <a:buFont typeface="Arial" pitchFamily="34" charset="0"/>
        <a:buChar char="•"/>
        <a:defRPr sz="6163" kern="1200">
          <a:solidFill>
            <a:schemeClr val="tx1"/>
          </a:solidFill>
          <a:latin typeface="+mn-lt"/>
          <a:ea typeface="+mn-ea"/>
          <a:cs typeface="+mn-cs"/>
        </a:defRPr>
      </a:lvl3pPr>
      <a:lvl4pPr marL="4109081" indent="-587011" algn="l" defTabSz="2348046" rtl="0" eaLnBrk="1" latinLnBrk="0" hangingPunct="1">
        <a:spcBef>
          <a:spcPct val="20000"/>
        </a:spcBef>
        <a:buFont typeface="Arial" pitchFamily="34" charset="0"/>
        <a:buChar char="–"/>
        <a:defRPr sz="5136" kern="1200">
          <a:solidFill>
            <a:schemeClr val="tx1"/>
          </a:solidFill>
          <a:latin typeface="+mn-lt"/>
          <a:ea typeface="+mn-ea"/>
          <a:cs typeface="+mn-cs"/>
        </a:defRPr>
      </a:lvl4pPr>
      <a:lvl5pPr marL="5283104" indent="-587011" algn="l" defTabSz="2348046" rtl="0" eaLnBrk="1" latinLnBrk="0" hangingPunct="1">
        <a:spcBef>
          <a:spcPct val="20000"/>
        </a:spcBef>
        <a:buFont typeface="Arial" pitchFamily="34" charset="0"/>
        <a:buChar char="»"/>
        <a:defRPr sz="5136" kern="1200">
          <a:solidFill>
            <a:schemeClr val="tx1"/>
          </a:solidFill>
          <a:latin typeface="+mn-lt"/>
          <a:ea typeface="+mn-ea"/>
          <a:cs typeface="+mn-cs"/>
        </a:defRPr>
      </a:lvl5pPr>
      <a:lvl6pPr marL="6457127" indent="-587011" algn="l" defTabSz="2348046" rtl="0" eaLnBrk="1" latinLnBrk="0" hangingPunct="1">
        <a:spcBef>
          <a:spcPct val="20000"/>
        </a:spcBef>
        <a:buFont typeface="Arial" pitchFamily="34" charset="0"/>
        <a:buChar char="•"/>
        <a:defRPr sz="5136" kern="1200">
          <a:solidFill>
            <a:schemeClr val="tx1"/>
          </a:solidFill>
          <a:latin typeface="+mn-lt"/>
          <a:ea typeface="+mn-ea"/>
          <a:cs typeface="+mn-cs"/>
        </a:defRPr>
      </a:lvl6pPr>
      <a:lvl7pPr marL="7631149" indent="-587011" algn="l" defTabSz="2348046" rtl="0" eaLnBrk="1" latinLnBrk="0" hangingPunct="1">
        <a:spcBef>
          <a:spcPct val="20000"/>
        </a:spcBef>
        <a:buFont typeface="Arial" pitchFamily="34" charset="0"/>
        <a:buChar char="•"/>
        <a:defRPr sz="5136" kern="1200">
          <a:solidFill>
            <a:schemeClr val="tx1"/>
          </a:solidFill>
          <a:latin typeface="+mn-lt"/>
          <a:ea typeface="+mn-ea"/>
          <a:cs typeface="+mn-cs"/>
        </a:defRPr>
      </a:lvl7pPr>
      <a:lvl8pPr marL="8805172" indent="-587011" algn="l" defTabSz="2348046" rtl="0" eaLnBrk="1" latinLnBrk="0" hangingPunct="1">
        <a:spcBef>
          <a:spcPct val="20000"/>
        </a:spcBef>
        <a:buFont typeface="Arial" pitchFamily="34" charset="0"/>
        <a:buChar char="•"/>
        <a:defRPr sz="5136" kern="1200">
          <a:solidFill>
            <a:schemeClr val="tx1"/>
          </a:solidFill>
          <a:latin typeface="+mn-lt"/>
          <a:ea typeface="+mn-ea"/>
          <a:cs typeface="+mn-cs"/>
        </a:defRPr>
      </a:lvl8pPr>
      <a:lvl9pPr marL="9979195" indent="-587011" algn="l" defTabSz="2348046" rtl="0" eaLnBrk="1" latinLnBrk="0" hangingPunct="1">
        <a:spcBef>
          <a:spcPct val="20000"/>
        </a:spcBef>
        <a:buFont typeface="Arial" pitchFamily="34" charset="0"/>
        <a:buChar char="•"/>
        <a:defRPr sz="513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1pPr>
      <a:lvl2pPr marL="1174023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2pPr>
      <a:lvl3pPr marL="2348046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3pPr>
      <a:lvl4pPr marL="3522068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4pPr>
      <a:lvl5pPr marL="4696093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5pPr>
      <a:lvl6pPr marL="5870115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6pPr>
      <a:lvl7pPr marL="7044138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7pPr>
      <a:lvl8pPr marL="8218161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8pPr>
      <a:lvl9pPr marL="9392184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8" name="Textfeld 687">
            <a:extLst>
              <a:ext uri="{FF2B5EF4-FFF2-40B4-BE49-F238E27FC236}">
                <a16:creationId xmlns:a16="http://schemas.microsoft.com/office/drawing/2014/main" id="{72D07090-FAF9-4C35-8F86-5CDE0B4CBD9C}"/>
              </a:ext>
            </a:extLst>
          </p:cNvPr>
          <p:cNvSpPr txBox="1"/>
          <p:nvPr/>
        </p:nvSpPr>
        <p:spPr>
          <a:xfrm>
            <a:off x="0" y="7282496"/>
            <a:ext cx="6858000" cy="1460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ts val="1800"/>
              </a:lnSpc>
            </a:pPr>
            <a:r>
              <a:rPr lang="de-DE" sz="1200" b="1" dirty="0"/>
              <a:t>Figure S2: t-SNE </a:t>
            </a:r>
            <a:r>
              <a:rPr lang="de-DE" sz="1200" b="1" dirty="0" err="1"/>
              <a:t>analysis</a:t>
            </a:r>
            <a:r>
              <a:rPr lang="de-DE" sz="1200" b="1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taxonomic</a:t>
            </a:r>
            <a:r>
              <a:rPr lang="de-DE" sz="1200" dirty="0"/>
              <a:t> </a:t>
            </a:r>
            <a:r>
              <a:rPr lang="de-DE" sz="1200" dirty="0" err="1"/>
              <a:t>composition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14 </a:t>
            </a:r>
            <a:r>
              <a:rPr lang="de-DE" sz="1200" i="1" dirty="0" err="1"/>
              <a:t>Coleofasciculus</a:t>
            </a:r>
            <a:r>
              <a:rPr lang="de-DE" sz="1200" dirty="0"/>
              <a:t> </a:t>
            </a:r>
            <a:r>
              <a:rPr lang="de-DE" sz="1200" dirty="0" err="1"/>
              <a:t>microbiomes</a:t>
            </a:r>
            <a:r>
              <a:rPr lang="de-DE" sz="1200" dirty="0"/>
              <a:t>. The </a:t>
            </a:r>
            <a:r>
              <a:rPr lang="de-DE" sz="1200" dirty="0" err="1"/>
              <a:t>underlying</a:t>
            </a:r>
            <a:r>
              <a:rPr lang="de-DE" sz="1200" dirty="0"/>
              <a:t> </a:t>
            </a:r>
            <a:r>
              <a:rPr lang="de-DE" sz="1200" dirty="0" err="1"/>
              <a:t>taxonomic</a:t>
            </a:r>
            <a:r>
              <a:rPr lang="de-DE" sz="1200" dirty="0"/>
              <a:t> </a:t>
            </a:r>
            <a:r>
              <a:rPr lang="de-DE" sz="1200" dirty="0" err="1"/>
              <a:t>assessment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306 MAGs </a:t>
            </a:r>
            <a:r>
              <a:rPr lang="de-DE" sz="1200" dirty="0" err="1"/>
              <a:t>from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cyanosphere</a:t>
            </a:r>
            <a:r>
              <a:rPr lang="de-DE" sz="1200" dirty="0"/>
              <a:t> ranging </a:t>
            </a:r>
            <a:r>
              <a:rPr lang="de-DE" sz="1200" dirty="0" err="1"/>
              <a:t>from</a:t>
            </a:r>
            <a:r>
              <a:rPr lang="de-DE" sz="1200" dirty="0"/>
              <a:t> </a:t>
            </a:r>
            <a:r>
              <a:rPr lang="de-DE" sz="1200" dirty="0" err="1"/>
              <a:t>species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/>
              <a:t>phylum</a:t>
            </a:r>
            <a:r>
              <a:rPr lang="de-DE" sz="1200" dirty="0"/>
              <a:t> </a:t>
            </a:r>
            <a:r>
              <a:rPr lang="de-DE" sz="1200" dirty="0" err="1"/>
              <a:t>level</a:t>
            </a:r>
            <a:r>
              <a:rPr lang="de-DE" sz="1200" dirty="0"/>
              <a:t> was </a:t>
            </a:r>
            <a:r>
              <a:rPr lang="de-DE" sz="1200" dirty="0" err="1"/>
              <a:t>conducted</a:t>
            </a:r>
            <a:r>
              <a:rPr lang="de-DE" sz="1200" dirty="0"/>
              <a:t> </a:t>
            </a:r>
            <a:r>
              <a:rPr lang="de-DE" sz="1200" dirty="0" err="1"/>
              <a:t>based</a:t>
            </a:r>
            <a:r>
              <a:rPr lang="de-DE" sz="1200" dirty="0"/>
              <a:t> on </a:t>
            </a:r>
            <a:r>
              <a:rPr lang="de-DE" sz="1200" dirty="0" err="1"/>
              <a:t>the</a:t>
            </a:r>
            <a:r>
              <a:rPr lang="de-DE" sz="1200" dirty="0"/>
              <a:t> GTDB-</a:t>
            </a:r>
            <a:r>
              <a:rPr lang="de-DE" sz="1200" dirty="0" err="1"/>
              <a:t>Tk</a:t>
            </a:r>
            <a:r>
              <a:rPr lang="de-DE" sz="1200" dirty="0"/>
              <a:t> and TYGS </a:t>
            </a:r>
            <a:r>
              <a:rPr lang="de-DE" sz="1200" dirty="0" err="1"/>
              <a:t>analyses</a:t>
            </a:r>
            <a:r>
              <a:rPr lang="de-DE" sz="1200" dirty="0"/>
              <a:t> and </a:t>
            </a:r>
            <a:r>
              <a:rPr lang="de-DE" sz="1200" dirty="0" err="1"/>
              <a:t>presented</a:t>
            </a:r>
            <a:r>
              <a:rPr lang="de-DE" sz="1200" dirty="0"/>
              <a:t> in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phylogenomic</a:t>
            </a:r>
            <a:r>
              <a:rPr lang="de-DE" sz="1200" dirty="0"/>
              <a:t> </a:t>
            </a:r>
            <a:r>
              <a:rPr lang="de-DE" sz="1200" dirty="0" err="1"/>
              <a:t>tree</a:t>
            </a:r>
            <a:r>
              <a:rPr lang="de-DE" sz="1200" dirty="0"/>
              <a:t> (</a:t>
            </a:r>
            <a:r>
              <a:rPr lang="de-DE" sz="1200"/>
              <a:t>Figure S1A-F, </a:t>
            </a:r>
            <a:r>
              <a:rPr lang="de-DE" sz="1200" dirty="0"/>
              <a:t>Table S3). The </a:t>
            </a:r>
            <a:r>
              <a:rPr lang="de-DE" sz="1200" dirty="0" err="1"/>
              <a:t>origin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i="1" dirty="0" err="1"/>
              <a:t>Coleofasciculus</a:t>
            </a:r>
            <a:r>
              <a:rPr lang="de-DE" sz="1200" dirty="0"/>
              <a:t> </a:t>
            </a:r>
            <a:r>
              <a:rPr lang="de-DE" sz="1200" dirty="0" err="1"/>
              <a:t>cultures</a:t>
            </a:r>
            <a:r>
              <a:rPr lang="de-DE" sz="1200" dirty="0"/>
              <a:t> (</a:t>
            </a:r>
            <a:r>
              <a:rPr lang="de-DE" sz="1200" dirty="0" err="1"/>
              <a:t>sampling</a:t>
            </a:r>
            <a:r>
              <a:rPr lang="de-DE" sz="1200" dirty="0"/>
              <a:t> </a:t>
            </a:r>
            <a:r>
              <a:rPr lang="de-DE" sz="1200" dirty="0" err="1"/>
              <a:t>site</a:t>
            </a:r>
            <a:r>
              <a:rPr lang="de-DE" sz="1200" dirty="0"/>
              <a:t>) </a:t>
            </a:r>
            <a:r>
              <a:rPr lang="de-DE" sz="1200" dirty="0" err="1"/>
              <a:t>is</a:t>
            </a:r>
            <a:r>
              <a:rPr lang="de-DE" sz="1200" dirty="0"/>
              <a:t> </a:t>
            </a:r>
            <a:r>
              <a:rPr lang="de-DE" sz="1200" dirty="0" err="1"/>
              <a:t>indicated</a:t>
            </a:r>
            <a:r>
              <a:rPr lang="de-DE" sz="1200" dirty="0"/>
              <a:t> </a:t>
            </a:r>
            <a:r>
              <a:rPr lang="de-DE" sz="1200" dirty="0" err="1"/>
              <a:t>by</a:t>
            </a:r>
            <a:r>
              <a:rPr lang="de-DE" sz="1200" dirty="0"/>
              <a:t> different </a:t>
            </a:r>
            <a:r>
              <a:rPr lang="de-DE" sz="1200" dirty="0" err="1"/>
              <a:t>colors</a:t>
            </a:r>
            <a:r>
              <a:rPr lang="de-DE" sz="1200" dirty="0"/>
              <a:t>,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cultivation</a:t>
            </a:r>
            <a:r>
              <a:rPr lang="de-DE" sz="1200" dirty="0"/>
              <a:t> medium </a:t>
            </a:r>
            <a:r>
              <a:rPr lang="de-DE" sz="1200" dirty="0" err="1"/>
              <a:t>by</a:t>
            </a:r>
            <a:r>
              <a:rPr lang="de-DE" sz="1200" dirty="0"/>
              <a:t> </a:t>
            </a:r>
            <a:r>
              <a:rPr lang="de-DE" sz="1200" dirty="0" err="1"/>
              <a:t>circles</a:t>
            </a:r>
            <a:r>
              <a:rPr lang="de-DE" sz="1200" dirty="0"/>
              <a:t>, </a:t>
            </a:r>
            <a:r>
              <a:rPr lang="de-DE" sz="1200" dirty="0" err="1"/>
              <a:t>triangles</a:t>
            </a:r>
            <a:r>
              <a:rPr lang="de-DE" sz="1200" dirty="0"/>
              <a:t> and </a:t>
            </a:r>
            <a:r>
              <a:rPr lang="de-DE" sz="1200" dirty="0" err="1"/>
              <a:t>squares</a:t>
            </a:r>
            <a:r>
              <a:rPr lang="de-DE" sz="1200" dirty="0"/>
              <a:t>. Due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comparably</a:t>
            </a:r>
            <a:r>
              <a:rPr lang="de-DE" sz="1200" dirty="0"/>
              <a:t> </a:t>
            </a:r>
            <a:r>
              <a:rPr lang="de-DE" sz="1200" dirty="0" err="1"/>
              <a:t>small</a:t>
            </a:r>
            <a:r>
              <a:rPr lang="de-DE" sz="1200" dirty="0"/>
              <a:t> </a:t>
            </a:r>
            <a:r>
              <a:rPr lang="de-DE" sz="1200" dirty="0" err="1"/>
              <a:t>number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metagenome</a:t>
            </a:r>
            <a:r>
              <a:rPr lang="de-DE" sz="1200" dirty="0"/>
              <a:t> </a:t>
            </a:r>
            <a:r>
              <a:rPr lang="de-DE" sz="1200" dirty="0" err="1"/>
              <a:t>samples</a:t>
            </a:r>
            <a:r>
              <a:rPr lang="de-DE" sz="1200" dirty="0"/>
              <a:t>, </a:t>
            </a:r>
            <a:r>
              <a:rPr lang="de-DE" sz="1200" dirty="0" err="1"/>
              <a:t>we</a:t>
            </a:r>
            <a:r>
              <a:rPr lang="de-DE" sz="1200" dirty="0"/>
              <a:t> </a:t>
            </a:r>
            <a:r>
              <a:rPr lang="de-DE" sz="1200" dirty="0" err="1"/>
              <a:t>applied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highest</a:t>
            </a:r>
            <a:r>
              <a:rPr lang="de-DE" sz="1200" dirty="0"/>
              <a:t> </a:t>
            </a:r>
            <a:r>
              <a:rPr lang="de-DE" sz="1200" dirty="0" err="1"/>
              <a:t>acceptable</a:t>
            </a:r>
            <a:r>
              <a:rPr lang="de-DE" sz="1200" dirty="0"/>
              <a:t> </a:t>
            </a:r>
            <a:r>
              <a:rPr lang="de-DE" sz="1200" dirty="0" err="1"/>
              <a:t>perplexity</a:t>
            </a:r>
            <a:r>
              <a:rPr lang="de-DE" sz="1200" dirty="0"/>
              <a:t>.</a:t>
            </a:r>
            <a:endParaRPr lang="en-US" sz="1200" dirty="0"/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3B3CAC60-2E75-4359-8D3D-99231327F8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90869"/>
            <a:ext cx="6858000" cy="68765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859953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</Words>
  <Application>Microsoft Office PowerPoint</Application>
  <PresentationFormat>A4-Papier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SMZ</dc:creator>
  <cp:lastModifiedBy>Petersen, Jörn</cp:lastModifiedBy>
  <cp:revision>645</cp:revision>
  <cp:lastPrinted>2024-06-18T13:06:06Z</cp:lastPrinted>
  <dcterms:created xsi:type="dcterms:W3CDTF">2022-07-11T06:36:01Z</dcterms:created>
  <dcterms:modified xsi:type="dcterms:W3CDTF">2025-10-24T10:31:45Z</dcterms:modified>
</cp:coreProperties>
</file>